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57" r:id="rId4"/>
    <p:sldId id="256" r:id="rId5"/>
    <p:sldId id="260" r:id="rId6"/>
    <p:sldId id="259" r:id="rId7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710" y="58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8E856A7-CBF6-7314-303B-9582BFB1777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96EBADC-F4B6-9BF7-ABE2-7094575444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E998F22-71D1-9998-D34D-B45F2DD32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2DD577E-484A-14A4-7A09-D22A64492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34CDB78-2E77-4CDC-177E-4E0BCB1CA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6260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BF97EFE-3AB8-7C17-3ED8-BA68A74363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9F9BC23-6D18-006B-BFE4-8DA571054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665C97B-F9C9-EBC4-5899-3D04D76EC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B44A941-2FC4-0D55-8231-B7934FA1F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42664EF-A687-1012-38EE-380F522C3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2654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C37C9B3-ED66-FEF1-A4B4-A0E2515293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4D411F4-93E6-DEAD-B55D-92413DADC6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FA6DDED-BFAD-0A97-D5C7-23F1C02B3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CEB7407-7964-F709-CA45-C03547D8A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04A3098-FC8D-585D-0334-03B2C7651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21930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AEA695B-326F-E947-A2A8-2F1B31DB45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39D9DA7-AB91-307E-7296-B1B0C4BBE9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C914D95-F0F0-81C4-E65D-90F46F7C6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0275E5B-35FE-41C4-E32B-0BA20B958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9ABF0B0-9D44-B925-8273-71FD01700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0898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D21D000-463F-7BE3-46F7-988503C9D4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E94018B-AE24-A204-84DA-6200DD7566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4E13786-F5E5-867C-39F4-2DC15B67D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F9F483C-3B55-F898-17DA-CC68BBB2F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538714-347D-67F0-EF11-F072EF237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5826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1CE6310-38DB-CEBE-13BA-901B76F18B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10463C5-EDAF-32DA-6769-7373BA39F5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94730D7-901B-E05F-2143-4E48386805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BDE68A5-CE47-96FC-E082-7E63A899C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E623C7E-A15D-D83B-E4D4-B951485B0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7D8155D-B19C-90F1-4639-A819B47429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0975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56950DF-B9AB-3945-5C0E-D7046020EF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4BEA4B4-AA5D-77E4-C7C0-CCDDF427B4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BAC2970-FEA7-F99A-08A5-094C3FF8A0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6CF4EBB-41BE-FDB4-7A64-1DB0D67521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9958C2D-B9A3-E4C6-7588-74BE7BC943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93B11BF-0340-8258-7DC6-50A2A0BC2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84EA673-C5A1-48BA-B16C-C553EA97A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C162D38-7B46-F26E-096C-BE2B0C4F6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6857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6B81B9C-979F-73C5-0828-037463DD9B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F93DCAE-2730-FF2D-F34C-B4E2CE2D1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27B0C1A-B89C-12D4-921F-69DF4CE11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09F724C-CCC3-AE3B-4E8A-912ED5EEE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2911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53C1AF3-84B0-11DD-3BCF-6EAB80BAF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19E2B3B-C6F8-97F2-36CF-E4EDEA987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12DD768-F589-BEA0-DFF7-0B2D04F9E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679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8B37633-81C1-27E9-A057-661F3B7A6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B41ACFA-A2DA-1B7A-42CA-5E92A4CF76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A6D1A31-288F-F960-A165-3326F5787F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D80C81E-56BB-04BD-E907-C3D7D97FC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809CA59-501A-AB59-A426-A859C9EAE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F6FAC2A-59D4-3CAF-9EBA-0C3D51DA2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29708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06F35B8-DE37-2EA3-AF27-37DB0E2C63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DE7A910-26E8-0F5F-512F-5833A49C8A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61253F7-B0B1-29A0-F812-D080B4C9CF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28B18DF-66DA-BFF3-2429-E48A64A3E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75D3E41-F834-C0C9-AB34-FC46FABD9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55EE9BE-D114-5E58-E115-FAFD57B83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0409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E48728A-EED1-EA11-287A-42ECE76FE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86C7DA6-1867-676C-4129-6794D0F1D2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165EF92-7DF6-CF7A-A6EA-45FE600341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E495D-753B-4031-B04D-3E5EE1875145}" type="datetimeFigureOut">
              <a:rPr lang="it-IT" smtClean="0"/>
              <a:pPr/>
              <a:t>2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5C43671-53F1-A656-C1DA-D8842508C9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4D49D49-FA8F-CDED-D771-5D1131CFA8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10378-0446-47E0-A4DD-D061A3A9374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5598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9CFC9956-903D-A268-231E-174C39981D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3161" y="5009089"/>
            <a:ext cx="5465678" cy="8617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it-IT" sz="1600" b="1" i="0" u="none" strike="noStrike" cap="none" normalizeH="0" baseline="0" dirty="0">
                <a:ln>
                  <a:noFill/>
                </a:ln>
                <a:effectLst/>
                <a:ea typeface="Times New Roman" panose="02020603050405020304" pitchFamily="18" charset="0"/>
                <a:cs typeface="Cordia New" panose="020B0304020202020204" pitchFamily="34" charset="-34"/>
              </a:rPr>
              <a:t>Table S1. Microbial</a:t>
            </a:r>
            <a:r>
              <a:rPr kumimoji="0" lang="en-US" altLang="it-IT" sz="1600" b="1" i="0" u="none" strike="noStrike" cap="none" normalizeH="0" dirty="0">
                <a:ln>
                  <a:noFill/>
                </a:ln>
                <a:effectLst/>
                <a:ea typeface="Times New Roman" panose="02020603050405020304" pitchFamily="18" charset="0"/>
                <a:cs typeface="Cordia New" panose="020B0304020202020204" pitchFamily="34" charset="-34"/>
              </a:rPr>
              <a:t> </a:t>
            </a:r>
            <a:r>
              <a:rPr lang="en-US" altLang="it-IT" sz="1600" b="1" dirty="0">
                <a:ea typeface="Times New Roman" panose="02020603050405020304" pitchFamily="18" charset="0"/>
                <a:cs typeface="Cordia New" panose="020B0304020202020204" pitchFamily="34" charset="-34"/>
              </a:rPr>
              <a:t>c</a:t>
            </a:r>
            <a:r>
              <a:rPr kumimoji="0" lang="en-US" altLang="it-IT" sz="1600" b="1" i="0" u="none" strike="noStrike" cap="none" normalizeH="0" baseline="0" dirty="0">
                <a:ln>
                  <a:noFill/>
                </a:ln>
                <a:effectLst/>
                <a:ea typeface="Times New Roman" panose="02020603050405020304" pitchFamily="18" charset="0"/>
                <a:cs typeface="Cordia New" panose="020B0304020202020204" pitchFamily="34" charset="-34"/>
              </a:rPr>
              <a:t>omposition </a:t>
            </a:r>
            <a:r>
              <a:rPr lang="en-US" altLang="it-IT" sz="1600" b="1" dirty="0">
                <a:ea typeface="Times New Roman" panose="02020603050405020304" pitchFamily="18" charset="0"/>
                <a:cs typeface="Cordia New" panose="020B0304020202020204" pitchFamily="34" charset="-34"/>
              </a:rPr>
              <a:t>at family level of </a:t>
            </a:r>
            <a:r>
              <a:rPr lang="en-US" sz="1600" b="1" dirty="0"/>
              <a:t>the high ammonia-selected bacterial populations G5-2 and G5-4. </a:t>
            </a:r>
            <a:endParaRPr kumimoji="0" lang="it-IT" altLang="it-IT" sz="1600" b="1" i="0" u="none" strike="noStrike" cap="none" normalizeH="0" baseline="0" dirty="0">
              <a:ln>
                <a:noFill/>
              </a:ln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6" name="Tabella 5"/>
          <p:cNvGraphicFramePr>
            <a:graphicFrameLocks noGrp="1"/>
          </p:cNvGraphicFramePr>
          <p:nvPr/>
        </p:nvGraphicFramePr>
        <p:xfrm>
          <a:off x="3868102" y="692657"/>
          <a:ext cx="4029075" cy="3837633"/>
        </p:xfrm>
        <a:graphic>
          <a:graphicData uri="http://schemas.openxmlformats.org/drawingml/2006/table">
            <a:tbl>
              <a:tblPr/>
              <a:tblGrid>
                <a:gridCol w="21094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296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899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400" b="1">
                          <a:latin typeface="Arial"/>
                          <a:ea typeface="Calibri"/>
                          <a:cs typeface="Times New Roman"/>
                        </a:rPr>
                        <a:t>FAMILY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400" b="1">
                          <a:latin typeface="Arial"/>
                          <a:ea typeface="Calibri"/>
                          <a:cs typeface="Times New Roman"/>
                        </a:rPr>
                        <a:t>G5-2 (%)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400" b="1">
                          <a:latin typeface="Arial"/>
                          <a:ea typeface="Calibri"/>
                          <a:cs typeface="Times New Roman"/>
                        </a:rPr>
                        <a:t>G5-4 (%)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Xanthomonad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32.30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8.54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Alcaligen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21.31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33.81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Rhodobacter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10.53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10.38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Bradyrhizobi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6.96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6.16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Rhizobi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4.75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4.34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Comamonad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4.68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9.06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Brucell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4.35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Caulobacter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3.20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5.67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Phyllobacteri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2.53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3.98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Hyphomicrobi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2.50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6.61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latin typeface="Arial"/>
                          <a:ea typeface="Calibri"/>
                          <a:cs typeface="Times New Roman"/>
                        </a:rPr>
                        <a:t>Microbacteriaceae</a:t>
                      </a:r>
                      <a:endParaRPr lang="it-IT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1.98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4.00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Chitinophag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1.28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0.78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Micrococc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0.93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1.31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Sphingomonad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0.75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1.52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Isosphaer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0.49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Nitrosomonad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0.2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0.2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Gordoni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0.1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0.69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Chelatococc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1.34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Nocardiaceae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0.29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Other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latin typeface="Arial"/>
                          <a:ea typeface="Calibri"/>
                          <a:cs typeface="Times New Roman"/>
                        </a:rPr>
                        <a:t>1.18</a:t>
                      </a:r>
                      <a:endParaRPr lang="it-IT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latin typeface="Arial"/>
                          <a:ea typeface="Calibri"/>
                          <a:cs typeface="Times New Roman"/>
                        </a:rPr>
                        <a:t>1.32</a:t>
                      </a:r>
                      <a:endParaRPr lang="it-IT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>
            <a:extLst>
              <a:ext uri="{FF2B5EF4-FFF2-40B4-BE49-F238E27FC236}">
                <a16:creationId xmlns:a16="http://schemas.microsoft.com/office/drawing/2014/main" id="{9CFC9956-903D-A268-231E-174C39981D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2682" y="5131009"/>
            <a:ext cx="4183062" cy="8617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600" b="1" i="0" u="none" strike="noStrike" cap="none" normalizeH="0" baseline="0" dirty="0">
                <a:ln>
                  <a:noFill/>
                </a:ln>
                <a:effectLst/>
                <a:ea typeface="Times New Roman" panose="02020603050405020304" pitchFamily="18" charset="0"/>
                <a:cs typeface="Cordia New" panose="020B0304020202020204" pitchFamily="34" charset="-34"/>
              </a:rPr>
              <a:t>Table S2. </a:t>
            </a:r>
            <a:r>
              <a:rPr kumimoji="0" lang="en-US" altLang="it-IT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ordia New" panose="020B0304020202020204" pitchFamily="34" charset="-34"/>
              </a:rPr>
              <a:t>Average composition of pre-treated leachates used in our experiments.</a:t>
            </a:r>
            <a:endParaRPr kumimoji="0" lang="it-IT" altLang="it-IT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8" name="Tabella 7">
            <a:extLst>
              <a:ext uri="{FF2B5EF4-FFF2-40B4-BE49-F238E27FC236}">
                <a16:creationId xmlns:a16="http://schemas.microsoft.com/office/drawing/2014/main" id="{51B2EA26-7170-1954-A1AC-6D11FF294B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3239889"/>
              </p:ext>
            </p:extLst>
          </p:nvPr>
        </p:nvGraphicFramePr>
        <p:xfrm>
          <a:off x="4616809" y="392573"/>
          <a:ext cx="2989006" cy="4592074"/>
        </p:xfrm>
        <a:graphic>
          <a:graphicData uri="http://schemas.openxmlformats.org/drawingml/2006/table">
            <a:tbl>
              <a:tblPr/>
              <a:tblGrid>
                <a:gridCol w="1616843">
                  <a:extLst>
                    <a:ext uri="{9D8B030D-6E8A-4147-A177-3AD203B41FA5}">
                      <a16:colId xmlns:a16="http://schemas.microsoft.com/office/drawing/2014/main" val="2968066325"/>
                    </a:ext>
                  </a:extLst>
                </a:gridCol>
                <a:gridCol w="1372163">
                  <a:extLst>
                    <a:ext uri="{9D8B030D-6E8A-4147-A177-3AD203B41FA5}">
                      <a16:colId xmlns:a16="http://schemas.microsoft.com/office/drawing/2014/main" val="814908748"/>
                    </a:ext>
                  </a:extLst>
                </a:gridCol>
              </a:tblGrid>
              <a:tr h="329093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arameter</a:t>
                      </a:r>
                      <a:r>
                        <a:rPr lang="it-IT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       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Value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095642"/>
                  </a:ext>
                </a:extLst>
              </a:tr>
              <a:tr h="237678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lor               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rk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rown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9246817"/>
                  </a:ext>
                </a:extLst>
              </a:tr>
              <a:tr h="329093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mell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               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trong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5370501"/>
                  </a:ext>
                </a:extLst>
              </a:tr>
              <a:tr h="329093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H                       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.6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342037"/>
                  </a:ext>
                </a:extLst>
              </a:tr>
              <a:tr h="237678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D (mg/L)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066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463687"/>
                  </a:ext>
                </a:extLst>
              </a:tr>
              <a:tr h="237678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OD (mg/L O</a:t>
                      </a:r>
                      <a:r>
                        <a:rPr lang="it-IT" sz="12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07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0359075"/>
                  </a:ext>
                </a:extLst>
              </a:tr>
              <a:tr h="386599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OD/COD        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0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8837588"/>
                  </a:ext>
                </a:extLst>
              </a:tr>
              <a:tr h="227290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H</a:t>
                      </a:r>
                      <a:r>
                        <a:rPr lang="it-IT" sz="12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it-IT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+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N (mg/L)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           1415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859304"/>
                  </a:ext>
                </a:extLst>
              </a:tr>
              <a:tr h="237678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O</a:t>
                      </a:r>
                      <a:r>
                        <a:rPr lang="it-IT" sz="12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it-IT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-N (mg/L)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5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8422936"/>
                  </a:ext>
                </a:extLst>
              </a:tr>
              <a:tr h="329093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O</a:t>
                      </a:r>
                      <a:r>
                        <a:rPr lang="it-IT" sz="12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it-IT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-N (mg/L)     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races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6068407"/>
                  </a:ext>
                </a:extLst>
              </a:tr>
              <a:tr h="146263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l</a:t>
                      </a:r>
                      <a:r>
                        <a:rPr lang="it-IT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(mg/L)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253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3801635"/>
                  </a:ext>
                </a:extLst>
              </a:tr>
              <a:tr h="146263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u (mg/L)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61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7373324"/>
                  </a:ext>
                </a:extLst>
              </a:tr>
              <a:tr h="329093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b (mg/L)             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05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0992618"/>
                  </a:ext>
                </a:extLst>
              </a:tr>
              <a:tr h="146263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 (mg/L)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04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4398361"/>
                  </a:ext>
                </a:extLst>
              </a:tr>
              <a:tr h="329093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i (mg/L)              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34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6273087"/>
                  </a:ext>
                </a:extLst>
              </a:tr>
              <a:tr h="329093">
                <a:tc>
                  <a:txBody>
                    <a:bodyPr/>
                    <a:lstStyle/>
                    <a:p>
                      <a:pPr algn="l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Zn (mg/L)                    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06</a:t>
                      </a:r>
                      <a:endParaRPr lang="it-IT" sz="1200" dirty="0">
                        <a:effectLst/>
                      </a:endParaRPr>
                    </a:p>
                  </a:txBody>
                  <a:tcPr marL="54849" marR="54849" marT="27424" marB="27424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94327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428296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8E2CF5D0-AC3C-4004-8228-0F80B48ECD6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7795" y="931384"/>
            <a:ext cx="5803192" cy="3435891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608A95F4-B9BA-BC7D-6A59-1B6A86500EC6}"/>
              </a:ext>
            </a:extLst>
          </p:cNvPr>
          <p:cNvSpPr txBox="1"/>
          <p:nvPr/>
        </p:nvSpPr>
        <p:spPr>
          <a:xfrm>
            <a:off x="3039091" y="4407351"/>
            <a:ext cx="63610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/>
              <a:t>0.3 </a:t>
            </a:r>
            <a:r>
              <a:rPr lang="it-IT" sz="1600" b="1" dirty="0">
                <a:sym typeface="Symbol" panose="05050102010706020507" pitchFamily="18" charset="2"/>
              </a:rPr>
              <a:t> 0.04           1.9  0.03                        1.7  0.05                        1.9  0.05  </a:t>
            </a:r>
            <a:endParaRPr lang="it-IT" sz="1600" b="1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C60EB04D-B8C8-B290-4365-7AC2CB3848D0}"/>
              </a:ext>
            </a:extLst>
          </p:cNvPr>
          <p:cNvSpPr txBox="1"/>
          <p:nvPr/>
        </p:nvSpPr>
        <p:spPr>
          <a:xfrm>
            <a:off x="2770414" y="4926174"/>
            <a:ext cx="6863444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dirty="0"/>
              <a:t>Figure S1. Crystal Violet Staining. </a:t>
            </a:r>
            <a:r>
              <a:rPr lang="en-US" sz="1600" dirty="0"/>
              <a:t>K-</a:t>
            </a:r>
            <a:r>
              <a:rPr lang="en-US" sz="1600" dirty="0" err="1">
                <a:effectLst/>
                <a:ea typeface="Calibri" panose="020F0502020204030204" pitchFamily="34" charset="0"/>
                <a:cs typeface="AdvTTc9617e0c.B"/>
              </a:rPr>
              <a:t>Kaldnes</a:t>
            </a:r>
            <a:r>
              <a:rPr lang="en-US" sz="1600" dirty="0"/>
              <a:t> bio-carriers from control no cells (C), selected bacterial species (G5-4 and G1-2) and activated sludge (SL) were stained with crystal violet dye as described in </a:t>
            </a:r>
            <a:r>
              <a:rPr lang="en-US" sz="1600" i="1" dirty="0"/>
              <a:t>Materials and Methods. </a:t>
            </a:r>
            <a:r>
              <a:rPr lang="en-US" sz="1600" dirty="0"/>
              <a:t>The Optical density (OD</a:t>
            </a:r>
            <a:r>
              <a:rPr lang="en-US" sz="1600" baseline="-25000" dirty="0"/>
              <a:t>600</a:t>
            </a:r>
            <a:r>
              <a:rPr lang="en-US" sz="1600" dirty="0"/>
              <a:t>) of the colored ethanol  solution was measured for the four bio-carriers of each sample and the mean </a:t>
            </a:r>
            <a:r>
              <a:rPr lang="en-US" sz="1600" dirty="0">
                <a:sym typeface="Symbol" panose="05050102010706020507" pitchFamily="18" charset="2"/>
              </a:rPr>
              <a:t> </a:t>
            </a:r>
            <a:r>
              <a:rPr lang="en-US" sz="1600" dirty="0"/>
              <a:t>standard deviation are reported.</a:t>
            </a:r>
          </a:p>
        </p:txBody>
      </p:sp>
    </p:spTree>
    <p:extLst>
      <p:ext uri="{BB962C8B-B14F-4D97-AF65-F5344CB8AC3E}">
        <p14:creationId xmlns:p14="http://schemas.microsoft.com/office/powerpoint/2010/main" val="22815387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7EBBEF1A-9EDA-9F5A-F471-09083C3A3CC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8028" y="1096771"/>
            <a:ext cx="8695944" cy="3191256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8AF63E0B-0A6A-A573-B6D3-5B874470F62E}"/>
              </a:ext>
            </a:extLst>
          </p:cNvPr>
          <p:cNvSpPr txBox="1"/>
          <p:nvPr/>
        </p:nvSpPr>
        <p:spPr>
          <a:xfrm>
            <a:off x="1397000" y="4308931"/>
            <a:ext cx="9398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Figure S2. </a:t>
            </a:r>
            <a:r>
              <a:rPr lang="en-US" sz="1600" b="1" dirty="0">
                <a:solidFill>
                  <a:srgbClr val="000000"/>
                </a:solidFill>
                <a:highlight>
                  <a:srgbClr val="FFFFFF"/>
                </a:highlight>
                <a:cs typeface="Times New Roman" panose="02020603050405020304" pitchFamily="18" charset="0"/>
              </a:rPr>
              <a:t>Bio</a:t>
            </a:r>
            <a:r>
              <a:rPr lang="en-US" sz="16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ea typeface="Calibri" panose="020F0502020204030204" pitchFamily="34" charset="0"/>
                <a:cs typeface="Times New Roman" panose="02020603050405020304" pitchFamily="18" charset="0"/>
              </a:rPr>
              <a:t>-Repetitive Re-Inoculum Assay </a:t>
            </a:r>
            <a:r>
              <a:rPr lang="en-US" sz="16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ea typeface="Calibri" panose="020F0502020204030204" pitchFamily="34" charset="0"/>
                <a:cs typeface="Times New Roman" panose="02020603050405020304" pitchFamily="18" charset="0"/>
              </a:rPr>
              <a:t>by G1-2 </a:t>
            </a:r>
            <a:r>
              <a:rPr lang="en-US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5-2 and G5-4 MBBs.</a:t>
            </a:r>
            <a:r>
              <a:rPr lang="en-US" sz="16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b="1" dirty="0">
                <a:solidFill>
                  <a:srgbClr val="222222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600" dirty="0">
                <a:solidFill>
                  <a:srgbClr val="222222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 experiment has been carried out as described in </a:t>
            </a:r>
            <a:r>
              <a:rPr lang="en-US" sz="1600" b="1" dirty="0">
                <a:solidFill>
                  <a:srgbClr val="222222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igure 3A </a:t>
            </a:r>
            <a:r>
              <a:rPr lang="en-US" sz="1600" dirty="0">
                <a:solidFill>
                  <a:srgbClr val="222222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xcept for the higher NH</a:t>
            </a:r>
            <a:r>
              <a:rPr lang="en-US" sz="1600" baseline="-25000" dirty="0">
                <a:solidFill>
                  <a:srgbClr val="222222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600" baseline="30000" dirty="0">
                <a:solidFill>
                  <a:srgbClr val="222222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solidFill>
                  <a:srgbClr val="222222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N concentration (425 mg/L). The three biofilms G1-2, G5-2 and G5-4 were tested.</a:t>
            </a:r>
            <a:r>
              <a:rPr lang="en-US" sz="1600" b="1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B. </a:t>
            </a:r>
            <a:r>
              <a:rPr lang="en-US" sz="16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amples</a:t>
            </a:r>
            <a:r>
              <a:rPr lang="en-US" sz="1600" b="1" dirty="0">
                <a:solidFill>
                  <a:srgbClr val="FF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222222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rom panel A were withdrawn at indicated times  for </a:t>
            </a:r>
            <a:r>
              <a:rPr lang="en-US" sz="16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NO</a:t>
            </a:r>
            <a:r>
              <a:rPr lang="en-US" sz="1600" baseline="-250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600" baseline="300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US" sz="1600" dirty="0">
                <a:solidFill>
                  <a:srgbClr val="222222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etermination. </a:t>
            </a:r>
            <a:endParaRPr lang="it-IT" sz="1600" dirty="0"/>
          </a:p>
        </p:txBody>
      </p:sp>
    </p:spTree>
    <p:extLst>
      <p:ext uri="{BB962C8B-B14F-4D97-AF65-F5344CB8AC3E}">
        <p14:creationId xmlns:p14="http://schemas.microsoft.com/office/powerpoint/2010/main" val="38275599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50A421D9-559F-5E6C-AAAC-6227BD70BB7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2728" y="740283"/>
            <a:ext cx="9686544" cy="3720084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1D59DF9B-0A8C-AAE8-89AF-9CC308A4F920}"/>
              </a:ext>
            </a:extLst>
          </p:cNvPr>
          <p:cNvSpPr txBox="1"/>
          <p:nvPr/>
        </p:nvSpPr>
        <p:spPr>
          <a:xfrm>
            <a:off x="1657350" y="4527042"/>
            <a:ext cx="9010650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</a:t>
            </a:r>
            <a:r>
              <a:rPr lang="en-US" sz="16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o-Repetitive Re-Inoculum Assay </a:t>
            </a:r>
            <a:r>
              <a:rPr lang="en-US" sz="16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y sludge MBBs.</a:t>
            </a:r>
            <a:r>
              <a:rPr lang="en-US" sz="16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ludge samples (SL5 and SL6) were taken at different periods from the Porto </a:t>
            </a:r>
            <a:r>
              <a:rPr lang="en-US" sz="1600" dirty="0" err="1">
                <a:solidFill>
                  <a:srgbClr val="222222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nt’Elpidio</a:t>
            </a:r>
            <a:r>
              <a:rPr lang="en-US" sz="16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municipal WWTP</a:t>
            </a:r>
            <a:r>
              <a:rPr lang="en-US" sz="1600" dirty="0">
                <a:solidFill>
                  <a:srgbClr val="222222"/>
                </a:solidFill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</a:t>
            </a:r>
            <a:r>
              <a:rPr lang="en-US" sz="16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io-carriers preparation. The ammonia removal by </a:t>
            </a:r>
            <a:r>
              <a:rPr lang="en-US" sz="1600" dirty="0">
                <a:solidFill>
                  <a:srgbClr val="222222"/>
                </a:solidFill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6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ofilms were investigated in Bio-RRIA experiments essentially as described in the legend of </a:t>
            </a:r>
            <a:r>
              <a:rPr lang="en-US" sz="16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5.</a:t>
            </a:r>
            <a:endParaRPr lang="it-IT" sz="16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D6096DC8-4B89-6F7C-F42C-80B027E0BF61}"/>
              </a:ext>
            </a:extLst>
          </p:cNvPr>
          <p:cNvSpPr txBox="1"/>
          <p:nvPr/>
        </p:nvSpPr>
        <p:spPr>
          <a:xfrm>
            <a:off x="1388345" y="4875426"/>
            <a:ext cx="9486538" cy="18466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igure S4.</a:t>
            </a: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uLnTx/>
                <a:uFillTx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hange of biofilm population from the ammonia-selected </a:t>
            </a:r>
            <a:r>
              <a:rPr lang="en-US" sz="16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icrobial communities G5-2 and G5-4</a:t>
            </a:r>
            <a:r>
              <a:rPr lang="en-US" sz="1600" b="1" dirty="0">
                <a:solidFill>
                  <a:srgbClr val="000000"/>
                </a:solidFill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  <a:r>
              <a:rPr lang="en-US" sz="16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lative abundance (%) of the most prevalent genera in the biofilms derived from G5-2 (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 G5-4 (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essentially as described in the legend of 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5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Samples were the bacterial cultures used for biofilm formation (grey bars) and MBBs taken on the 1</a:t>
            </a:r>
            <a:r>
              <a:rPr lang="en-US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ay (green bars), on the 10</a:t>
            </a:r>
            <a:r>
              <a:rPr lang="en-US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ay (red bars) and on the 15</a:t>
            </a:r>
            <a:r>
              <a:rPr lang="en-US" sz="16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ay (dark blue bars) of Bio-RRIA. The bar graph shows only genera that contributed more than 4% to the total OTUs in at least one point. </a:t>
            </a:r>
            <a:endParaRPr lang="it-IT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it-IT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8D13316A-F9AE-053D-864B-5230FB6A35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4460" y="387477"/>
            <a:ext cx="9403080" cy="44637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94554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6</TotalTime>
  <Words>512</Words>
  <Application>Microsoft Office PowerPoint</Application>
  <PresentationFormat>Widescreen</PresentationFormat>
  <Paragraphs>102</Paragraphs>
  <Slides>6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6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Palatino Linotype</vt:lpstr>
      <vt:lpstr>Symbol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m.falconi1959@gmail.com</cp:lastModifiedBy>
  <cp:revision>68</cp:revision>
  <dcterms:created xsi:type="dcterms:W3CDTF">2023-10-14T14:05:03Z</dcterms:created>
  <dcterms:modified xsi:type="dcterms:W3CDTF">2024-11-22T11:02:06Z</dcterms:modified>
</cp:coreProperties>
</file>